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546102-4655-43FE-916D-C36EC7A929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275A4-8F46-4716-BC5E-ECA5A4D732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DFF3E-0156-4111-8AE7-9279098967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F2BEC0-0E08-4AFE-902C-89C397B0BB7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CCD5FD-5340-4D8E-9615-0EE92BEA12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72286F-65DF-4182-8682-9AEC0F9B8F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B94CC8-4351-428A-8A76-A67CA2817E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DB5CC9-3305-456D-AA2B-E3A36A7835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5A2C81-CE12-4095-9445-966D2AD9A2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C9E16B-6AB7-4A40-86FB-3F8AB14A88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355356-F8FC-426C-A7AC-20F82E7EA2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37E9D8-EB11-40D5-9FB8-052B5541DA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D58651-EC42-4604-80B4-A67FD26794CD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29"/>
          <p:cNvGraphicFramePr/>
          <p:nvPr/>
        </p:nvGraphicFramePr>
        <p:xfrm>
          <a:off x="2286000" y="1643040"/>
          <a:ext cx="4572000" cy="36576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29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86000" y="1643040"/>
                    <a:ext cx="4572000" cy="3657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CasellaDiTesto 4"/>
          <p:cNvSpPr/>
          <p:nvPr/>
        </p:nvSpPr>
        <p:spPr>
          <a:xfrm>
            <a:off x="2500200" y="785880"/>
            <a:ext cx="3929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Figure S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CasellaDiTesto 3"/>
          <p:cNvSpPr/>
          <p:nvPr/>
        </p:nvSpPr>
        <p:spPr>
          <a:xfrm>
            <a:off x="406440" y="5429160"/>
            <a:ext cx="83966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Q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uantitative analysis of un-conjugated bile acids in  BDL serum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DL   increases   serum concentrations of CA and CDCA while secondary bile acids were not detected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inor changes in  DCA and LCA in BDL mice administered 6-ECDA are not significant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ata are mean ± SE of 4 mice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16T13:52:08Z</dcterms:created>
  <dc:creator> </dc:creator>
  <dc:description/>
  <dc:language>en-US</dc:language>
  <cp:lastModifiedBy> </cp:lastModifiedBy>
  <dcterms:modified xsi:type="dcterms:W3CDTF">2011-12-17T10:02:17Z</dcterms:modified>
  <cp:revision>2</cp:revision>
  <dc:subject/>
  <dc:title>Diapositiva 1</dc:title>
</cp:coreProperties>
</file>